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660"/>
  </p:normalViewPr>
  <p:slideViewPr>
    <p:cSldViewPr snapToGrid="0">
      <p:cViewPr>
        <p:scale>
          <a:sx n="125" d="100"/>
          <a:sy n="125" d="100"/>
        </p:scale>
        <p:origin x="-127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293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33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521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422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983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214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514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200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727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246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372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98C60-06F5-4A3F-8D93-1C7F981FFFB4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086C7-C823-4115-B346-41767DF8A429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844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31886" y="5027426"/>
            <a:ext cx="889781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ditional file 7: Figure S3.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s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phenotypic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ues of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protein (a), fat (b), lactose (c) and dry matter (d), milk yield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rmalized to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10 days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e),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of lactation (f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logarithmically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formed somatic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g) recorded in the first lactation of </a:t>
            </a:r>
            <a:r>
              <a:rPr lang="en-GB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rciano-Granadina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oats. The raw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matic 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count is 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× 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altLang="zh-CN" sz="1600" baseline="30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/mL</a:t>
            </a:r>
            <a:r>
              <a:rPr lang="en-US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hown in (h)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085" y="260557"/>
            <a:ext cx="9063416" cy="4220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2740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81</Words>
  <Application>Microsoft Office PowerPoint</Application>
  <PresentationFormat>Presentación en pantalla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ilu Guan</dc:creator>
  <cp:lastModifiedBy>ma</cp:lastModifiedBy>
  <cp:revision>26</cp:revision>
  <dcterms:created xsi:type="dcterms:W3CDTF">2019-08-02T16:10:49Z</dcterms:created>
  <dcterms:modified xsi:type="dcterms:W3CDTF">2020-01-16T17:44:39Z</dcterms:modified>
</cp:coreProperties>
</file>